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A9D719-23D1-483D-9E9F-DC2CAD68CE2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5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. Figure 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hest CT scans before (left) and after (right) progression of lung tumors. Note that pleural effusion was detected in left cavity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698FE-C860-488C-A30A-6C3BBB5A8D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C08EB-24EE-4BA4-81BF-459571155C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ABD6D-D57E-4347-8C61-A23FF27A98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5A198-3E34-4828-84A4-84C8BA1789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BC4993-5A49-4862-8A16-D29F5304B3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DA5EE-74D8-4C60-9F8C-0F19594857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B8F36-A40F-4511-B176-404C3134B5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4B61A-0653-4F0E-823C-04DB9B7CC3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2B2DD-2646-4CA9-83FB-27F1F2FBFD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9C4D4-E69E-43ED-8496-0543796B40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B1605-CFBA-4692-897A-0DAE52D69E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70D91-731D-4E2A-9F2A-E41DD087A8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D8D8B0-34EB-464E-B035-21F65C3069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642960" y="4892760"/>
            <a:ext cx="81500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ure S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hest CT scans before (left) and after (right) progression on gefitinib monotherapy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明朝"/>
              </a:rPr>
              <a:t>Note the new pleural effusion (arrow) on progression in the left thoracic cavity, from where tumor cells were obtained for molecular analysi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rcRect l="22956" t="17669" r="22783" b="12668"/>
          <a:stretch/>
        </p:blipFill>
        <p:spPr>
          <a:xfrm>
            <a:off x="2035080" y="1036800"/>
            <a:ext cx="2799000" cy="187452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2"/>
          <a:srcRect l="22956" t="20003" r="22783" b="8000"/>
          <a:stretch/>
        </p:blipFill>
        <p:spPr>
          <a:xfrm>
            <a:off x="4908600" y="1036800"/>
            <a:ext cx="2705040" cy="187308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5619600" y="3009960"/>
            <a:ext cx="126252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ogress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522520" y="3009960"/>
            <a:ext cx="1846440" cy="2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45720" rIns="45720" tIns="22680" bIns="22680" anchor="t">
            <a:spAutoFit/>
          </a:bodyPr>
          <a:p>
            <a:pPr>
              <a:tabLst>
                <a:tab algn="l" pos="0"/>
                <a:tab algn="l" pos="458640"/>
                <a:tab algn="l" pos="917640"/>
                <a:tab algn="l" pos="1376280"/>
                <a:tab algn="l" pos="1835280"/>
                <a:tab algn="l" pos="2293920"/>
                <a:tab algn="l" pos="2752560"/>
                <a:tab algn="l" pos="3211560"/>
                <a:tab algn="l" pos="3670200"/>
                <a:tab algn="l" pos="4129200"/>
                <a:tab algn="l" pos="4587840"/>
                <a:tab algn="l" pos="5046840"/>
                <a:tab algn="l" pos="5505480"/>
                <a:tab algn="l" pos="5964120"/>
                <a:tab algn="l" pos="6423120"/>
                <a:tab algn="l" pos="6881760"/>
                <a:tab algn="l" pos="7340760"/>
                <a:tab algn="l" pos="7799400"/>
                <a:tab algn="l" pos="8258040"/>
                <a:tab algn="l" pos="8717040"/>
                <a:tab algn="l" pos="91756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table on gefitini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H="1" flipV="1">
            <a:off x="6962760" y="2387160"/>
            <a:ext cx="295200" cy="274680"/>
          </a:xfrm>
          <a:prstGeom prst="line">
            <a:avLst/>
          </a:prstGeom>
          <a:ln w="381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07T12:29:41Z</dcterms:created>
  <dc:creator>SClark</dc:creator>
  <dc:description/>
  <dc:language>en-US</dc:language>
  <cp:lastModifiedBy>SClark</cp:lastModifiedBy>
  <dcterms:modified xsi:type="dcterms:W3CDTF">2007-09-07T12:29:47Z</dcterms:modified>
  <cp:revision>1</cp:revision>
  <dc:subject/>
  <dc:title>Slide 1</dc:title>
</cp:coreProperties>
</file>